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63" r:id="rId2"/>
    <p:sldId id="26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36E5086A-CCC3-F549-A31A-8426B99BB324}">
          <p14:sldIdLst>
            <p14:sldId id="263"/>
            <p14:sldId id="267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48481"/>
    <a:srgbClr val="D0E8D6"/>
    <a:srgbClr val="B884E3"/>
    <a:srgbClr val="9416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vertBarState="minimized">
    <p:restoredLeft sz="5574"/>
    <p:restoredTop sz="96006" autoAdjust="0"/>
  </p:normalViewPr>
  <p:slideViewPr>
    <p:cSldViewPr snapToGrid="0" snapToObjects="1">
      <p:cViewPr varScale="1">
        <p:scale>
          <a:sx n="91" d="100"/>
          <a:sy n="91" d="100"/>
        </p:scale>
        <p:origin x="2536" y="1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35ECED-EE70-9E44-9F8E-E933BD3C9964}" type="datetimeFigureOut">
              <a:rPr lang="en-US" smtClean="0"/>
              <a:t>3/30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2EB442-7291-4C43-8DC8-1E56110A5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139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2EB442-7291-4C43-8DC8-1E56110A595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5851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62920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48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92674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772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77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3313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0393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671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688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3378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6255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4C16A-0709-3546-BFF6-29293E3F224C}" type="datetimeFigureOut">
              <a:rPr lang="en-US" smtClean="0"/>
              <a:t>3/30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1C2D43-12FE-6C44-9D41-92D11EA71EF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1881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64D326F0-C24A-60F4-F334-78B5B5EB3ABE}"/>
              </a:ext>
            </a:extLst>
          </p:cNvPr>
          <p:cNvSpPr/>
          <p:nvPr/>
        </p:nvSpPr>
        <p:spPr>
          <a:xfrm>
            <a:off x="812671" y="3509767"/>
            <a:ext cx="5232657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g. S1. DFMO reduces SPD/SPM ratios in SRS patient fibroblast cell lines. 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broblasts with </a:t>
            </a:r>
            <a:r>
              <a:rPr lang="en-US" sz="1100" dirty="0" err="1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hypomorphic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mutations of SMS were treated 96 h with increases doses of DFMO. A dose-dependent reduction in SPD is observed concurrent with increased SPM concentrations. Data represent the means of duplicate determinations.</a:t>
            </a:r>
            <a:endParaRPr lang="en-US" sz="1100" b="1" baseline="300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08BC55F-EC5F-692B-29CE-24A4C48A713F}"/>
              </a:ext>
            </a:extLst>
          </p:cNvPr>
          <p:cNvSpPr/>
          <p:nvPr/>
        </p:nvSpPr>
        <p:spPr>
          <a:xfrm>
            <a:off x="812671" y="7367768"/>
            <a:ext cx="5232657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g. S2.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Concentrations of </a:t>
            </a:r>
            <a:r>
              <a:rPr lang="en-US" sz="1100" dirty="0" err="1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dcSAM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(</a:t>
            </a:r>
            <a:r>
              <a:rPr lang="en-US" sz="1100" b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and SAM (</a:t>
            </a:r>
            <a:r>
              <a:rPr lang="en-US" sz="1100" b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) in lymphoblastoid cell lines. In </a:t>
            </a:r>
            <a:r>
              <a:rPr lang="en-US" sz="1100" b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, cells are treated with 0.2 mM DFMO for 96 h. Data represent the means with SEM of 2 independent experiments.</a:t>
            </a:r>
            <a:endParaRPr lang="en-US" sz="1100" b="1" baseline="300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997D52F-9086-8047-ECE3-4B79289F368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31079" y="626346"/>
            <a:ext cx="4345517" cy="2819239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B2DCC2BA-E2C8-735B-DE72-A8D2F6B8E642}"/>
              </a:ext>
            </a:extLst>
          </p:cNvPr>
          <p:cNvGrpSpPr/>
          <p:nvPr/>
        </p:nvGrpSpPr>
        <p:grpSpPr>
          <a:xfrm>
            <a:off x="967938" y="4736777"/>
            <a:ext cx="4750364" cy="2514600"/>
            <a:chOff x="839922" y="4864793"/>
            <a:chExt cx="4750364" cy="2514600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CDB6C8E-5290-FD9F-CD0A-7B91F0632AF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31079" y="4864793"/>
              <a:ext cx="1943100" cy="2514600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97EFF467-E257-A4D0-99BA-441038E1BEB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986786" y="4901554"/>
              <a:ext cx="2603500" cy="2298700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C24E44C-A5C7-AC38-39E7-6A09FC827AA3}"/>
                </a:ext>
              </a:extLst>
            </p:cNvPr>
            <p:cNvSpPr txBox="1"/>
            <p:nvPr/>
          </p:nvSpPr>
          <p:spPr>
            <a:xfrm>
              <a:off x="839922" y="4898435"/>
              <a:ext cx="4277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A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2088D656-6164-0CDD-C564-7DCD1428EF0C}"/>
                </a:ext>
              </a:extLst>
            </p:cNvPr>
            <p:cNvSpPr txBox="1"/>
            <p:nvPr/>
          </p:nvSpPr>
          <p:spPr>
            <a:xfrm>
              <a:off x="3001207" y="4864793"/>
              <a:ext cx="42779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265968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3C09EE9F-169C-85CF-3707-A85B5043C408}"/>
              </a:ext>
            </a:extLst>
          </p:cNvPr>
          <p:cNvGrpSpPr/>
          <p:nvPr/>
        </p:nvGrpSpPr>
        <p:grpSpPr>
          <a:xfrm>
            <a:off x="801878" y="2447509"/>
            <a:ext cx="5254244" cy="2576626"/>
            <a:chOff x="857289" y="2413443"/>
            <a:chExt cx="5390319" cy="2564703"/>
          </a:xfrm>
        </p:grpSpPr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40F3A6D3-F432-4FEC-E9C4-6B9947443F2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70148" y="2456085"/>
              <a:ext cx="2777460" cy="2522061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668B4C97-A67F-95AA-4001-6972303E4D9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857289" y="2413443"/>
              <a:ext cx="2777460" cy="2522061"/>
            </a:xfrm>
            <a:prstGeom prst="rect">
              <a:avLst/>
            </a:prstGeom>
          </p:spPr>
        </p:pic>
      </p:grpSp>
      <p:sp>
        <p:nvSpPr>
          <p:cNvPr id="4" name="Rectangle 3">
            <a:extLst>
              <a:ext uri="{FF2B5EF4-FFF2-40B4-BE49-F238E27FC236}">
                <a16:creationId xmlns:a16="http://schemas.microsoft.com/office/drawing/2014/main" id="{02CC3053-09B0-280D-7C07-06B55D69E7E4}"/>
              </a:ext>
            </a:extLst>
          </p:cNvPr>
          <p:cNvSpPr/>
          <p:nvPr/>
        </p:nvSpPr>
        <p:spPr>
          <a:xfrm>
            <a:off x="801878" y="4992624"/>
            <a:ext cx="5254244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Fig. S3.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DFMO extends lifespan in female </a:t>
            </a:r>
            <a:r>
              <a:rPr lang="en-US" sz="1100" b="1" i="1" dirty="0" err="1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dSms</a:t>
            </a:r>
            <a:r>
              <a:rPr lang="en-US" sz="1100" b="1" i="1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-/- Drosophila.</a:t>
            </a:r>
            <a:r>
              <a:rPr lang="en-US" sz="1100" dirty="0">
                <a:latin typeface="Times New Roman" panose="02020603050405020304" pitchFamily="18" charset="0"/>
                <a:ea typeface="ＭＳ 明朝" panose="02020609040205080304" pitchFamily="49" charset="-128"/>
                <a:cs typeface="Times New Roman" panose="02020603050405020304" pitchFamily="18" charset="0"/>
              </a:rPr>
              <a:t> The indicated concentration of DFMO was administered in the feed and survival was observed.</a:t>
            </a:r>
            <a:r>
              <a:rPr lang="en-US" sz="11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 In (A), n =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1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2, 50, 53, and 53 in the 0, 0.5, 1, and 2 mM DFMO treatment groups, respectively; in (B), n = 50 and 53 in the 0 and 10 mM DFMO treatment groups, respectively. The resulting survival curves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compared using the </a:t>
            </a:r>
            <a:r>
              <a:rPr lang="en-US" sz="11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log-rank (Mantel-Cox) test. DAE, days after </a:t>
            </a:r>
            <a:r>
              <a:rPr lang="en-US" sz="1100" b="0" i="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eclosure</a:t>
            </a:r>
            <a:r>
              <a:rPr lang="en-US" sz="1100" b="0" i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100" b="1" baseline="30000" dirty="0">
              <a:effectLst/>
              <a:latin typeface="Times New Roman" panose="02020603050405020304" pitchFamily="18" charset="0"/>
              <a:ea typeface="ＭＳ 明朝" panose="02020609040205080304" pitchFamily="49" charset="-128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0CE52DC-B413-4E01-393C-75C0D9320FED}"/>
              </a:ext>
            </a:extLst>
          </p:cNvPr>
          <p:cNvSpPr txBox="1"/>
          <p:nvPr/>
        </p:nvSpPr>
        <p:spPr>
          <a:xfrm>
            <a:off x="684573" y="2450658"/>
            <a:ext cx="180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4A1173-3BB9-BBBF-EB41-902908A5BDDA}"/>
              </a:ext>
            </a:extLst>
          </p:cNvPr>
          <p:cNvSpPr txBox="1"/>
          <p:nvPr/>
        </p:nvSpPr>
        <p:spPr>
          <a:xfrm>
            <a:off x="3296582" y="2436180"/>
            <a:ext cx="18008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471745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Genesis">
      <a:dk1>
        <a:sysClr val="windowText" lastClr="000000"/>
      </a:dk1>
      <a:lt1>
        <a:sysClr val="window" lastClr="FFFFFF"/>
      </a:lt1>
      <a:dk2>
        <a:srgbClr val="465466"/>
      </a:dk2>
      <a:lt2>
        <a:srgbClr val="BBD7F8"/>
      </a:lt2>
      <a:accent1>
        <a:srgbClr val="80B606"/>
      </a:accent1>
      <a:accent2>
        <a:srgbClr val="E29F1D"/>
      </a:accent2>
      <a:accent3>
        <a:srgbClr val="2397E2"/>
      </a:accent3>
      <a:accent4>
        <a:srgbClr val="35ACA2"/>
      </a:accent4>
      <a:accent5>
        <a:srgbClr val="5430BB"/>
      </a:accent5>
      <a:accent6>
        <a:srgbClr val="8D34E0"/>
      </a:accent6>
      <a:hlink>
        <a:srgbClr val="00B0F0"/>
      </a:hlink>
      <a:folHlink>
        <a:srgbClr val="0070C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99</TotalTime>
  <Words>204</Words>
  <Application>Microsoft Macintosh PowerPoint</Application>
  <PresentationFormat>On-screen Show (4:3)</PresentationFormat>
  <Paragraphs>8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itor  </dc:creator>
  <cp:lastModifiedBy>Tracy Stewart</cp:lastModifiedBy>
  <cp:revision>189</cp:revision>
  <cp:lastPrinted>2023-03-22T17:13:05Z</cp:lastPrinted>
  <dcterms:created xsi:type="dcterms:W3CDTF">2019-07-19T15:02:16Z</dcterms:created>
  <dcterms:modified xsi:type="dcterms:W3CDTF">2023-03-30T19:52:57Z</dcterms:modified>
</cp:coreProperties>
</file>